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09" r:id="rId2"/>
    <p:sldId id="257" r:id="rId3"/>
    <p:sldId id="258" r:id="rId4"/>
    <p:sldId id="259" r:id="rId5"/>
    <p:sldId id="260" r:id="rId6"/>
    <p:sldId id="261" r:id="rId7"/>
    <p:sldId id="262" r:id="rId8"/>
    <p:sldId id="310" r:id="rId9"/>
    <p:sldId id="311" r:id="rId10"/>
    <p:sldId id="312" r:id="rId11"/>
    <p:sldId id="313" r:id="rId12"/>
    <p:sldId id="314" r:id="rId13"/>
    <p:sldId id="315" r:id="rId14"/>
    <p:sldId id="316" r:id="rId15"/>
    <p:sldId id="317" r:id="rId16"/>
    <p:sldId id="318" r:id="rId17"/>
    <p:sldId id="319" r:id="rId18"/>
    <p:sldId id="320" r:id="rId19"/>
    <p:sldId id="321" r:id="rId20"/>
    <p:sldId id="322" r:id="rId21"/>
    <p:sldId id="323" r:id="rId22"/>
    <p:sldId id="324" r:id="rId23"/>
    <p:sldId id="325" r:id="rId24"/>
    <p:sldId id="326" r:id="rId25"/>
    <p:sldId id="327" r:id="rId26"/>
    <p:sldId id="328" r:id="rId27"/>
  </p:sldIdLst>
  <p:sldSz cx="12192000" cy="6858000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22" d="100"/>
          <a:sy n="122" d="100"/>
        </p:scale>
        <p:origin x="96" y="2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6BE62CD-6F5A-4B0F-B648-240F829B1BF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Ondertitel 2">
            <a:extLst>
              <a:ext uri="{FF2B5EF4-FFF2-40B4-BE49-F238E27FC236}">
                <a16:creationId xmlns:a16="http://schemas.microsoft.com/office/drawing/2014/main" id="{DE744B49-6878-8A35-CD1B-0CCEC637713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/>
              <a:t>Klikken om de ondertitelstijl van het model te bewerken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E180DB40-C9D7-10A8-2D84-CB45E1F00B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82D00-E18D-4D66-B3EE-0BEE78E5CE9D}" type="datetimeFigureOut">
              <a:rPr lang="nl-NL" smtClean="0"/>
              <a:t>21-07-2022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D6AD555D-186E-B2B7-7E26-6C18904BB3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9E070BE8-D95B-3285-FD39-283F2D5900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059D-D019-4456-ABB0-D72F78B2AB1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6569678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2A727EE-4F5F-E653-4E74-1DD76B3DA6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verticale tekst 2">
            <a:extLst>
              <a:ext uri="{FF2B5EF4-FFF2-40B4-BE49-F238E27FC236}">
                <a16:creationId xmlns:a16="http://schemas.microsoft.com/office/drawing/2014/main" id="{C3E43CA1-6225-7525-9CDA-BD00FCB5AB1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6DCE3855-DA30-66AC-7DB6-ACE4ECBB2D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82D00-E18D-4D66-B3EE-0BEE78E5CE9D}" type="datetimeFigureOut">
              <a:rPr lang="nl-NL" smtClean="0"/>
              <a:t>21-07-2022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308E5EE3-FD27-80D9-E3AC-1BE9507788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29C40B72-94D0-4B8D-CB33-5FA0EB5DC5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059D-D019-4456-ABB0-D72F78B2AB1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2973089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>
            <a:extLst>
              <a:ext uri="{FF2B5EF4-FFF2-40B4-BE49-F238E27FC236}">
                <a16:creationId xmlns:a16="http://schemas.microsoft.com/office/drawing/2014/main" id="{C0B1E505-65DB-E897-6D0D-438C72540DC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verticale tekst 2">
            <a:extLst>
              <a:ext uri="{FF2B5EF4-FFF2-40B4-BE49-F238E27FC236}">
                <a16:creationId xmlns:a16="http://schemas.microsoft.com/office/drawing/2014/main" id="{CBA94604-1B35-28B9-EDB8-CC393900FDA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3C995327-7B05-6A01-3C69-2E9617ED50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82D00-E18D-4D66-B3EE-0BEE78E5CE9D}" type="datetimeFigureOut">
              <a:rPr lang="nl-NL" smtClean="0"/>
              <a:t>21-07-2022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45DBDF80-3E96-6C30-4B3B-FEFE8330B9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8286D720-B64C-80D6-A941-98A23C0158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059D-D019-4456-ABB0-D72F78B2AB1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6086596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554C2BB-BC4A-A427-3741-9FA4A688AE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BF019C61-8A7D-99D4-6DE2-E617E69F29F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F0214C0A-0BCC-CE8F-FC5B-B7E8001F8A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82D00-E18D-4D66-B3EE-0BEE78E5CE9D}" type="datetimeFigureOut">
              <a:rPr lang="nl-NL" smtClean="0"/>
              <a:t>21-07-2022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FDBB2FD7-A161-1B3B-54A0-4BA80B9F2F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16EF37A7-FB6C-DA9A-226E-FDA04D0A55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059D-D019-4456-ABB0-D72F78B2AB1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19268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583F55F-2515-2AAB-CEC5-A67F92770B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E3B58108-54E5-0247-992B-4106A59D12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09084E6A-33B7-A132-AE73-13D82F583D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82D00-E18D-4D66-B3EE-0BEE78E5CE9D}" type="datetimeFigureOut">
              <a:rPr lang="nl-NL" smtClean="0"/>
              <a:t>21-07-2022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0142F3D3-2BFC-5105-664F-75FFC1E415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E4D7356C-EEA2-7963-6C88-E09C9325BD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059D-D019-4456-ABB0-D72F78B2AB1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9495871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65D23AE-5289-7F14-BAF5-A98C106C6C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EAFE4997-97AA-A124-6A90-4DB9BB09992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:a16="http://schemas.microsoft.com/office/drawing/2014/main" id="{0155903E-7FBF-CEA0-D081-7DD59A6A4A5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9971F7B8-1FF7-7E3C-38EC-E379B8DA6A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82D00-E18D-4D66-B3EE-0BEE78E5CE9D}" type="datetimeFigureOut">
              <a:rPr lang="nl-NL" smtClean="0"/>
              <a:t>21-07-2022</a:t>
            </a:fld>
            <a:endParaRPr lang="nl-NL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5BF491C8-3B72-D210-2A26-774BF0C740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3AA00EF4-2C87-C925-A0A1-748204DA45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059D-D019-4456-ABB0-D72F78B2AB1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1782070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F17CAEA-F519-7D58-732C-C0E403A164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8F3877DE-4065-679F-5BE8-61B73D7578D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:a16="http://schemas.microsoft.com/office/drawing/2014/main" id="{8FB46C4B-8F21-9629-8538-3B8C991D25A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5" name="Tijdelijke aanduiding voor tekst 4">
            <a:extLst>
              <a:ext uri="{FF2B5EF4-FFF2-40B4-BE49-F238E27FC236}">
                <a16:creationId xmlns:a16="http://schemas.microsoft.com/office/drawing/2014/main" id="{E6ABC7CE-CCBC-A2F7-9AF8-7F107FE2B41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6" name="Tijdelijke aanduiding voor inhoud 5">
            <a:extLst>
              <a:ext uri="{FF2B5EF4-FFF2-40B4-BE49-F238E27FC236}">
                <a16:creationId xmlns:a16="http://schemas.microsoft.com/office/drawing/2014/main" id="{CB9BE71D-A693-7258-5F54-F726C9C7009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7" name="Tijdelijke aanduiding voor datum 6">
            <a:extLst>
              <a:ext uri="{FF2B5EF4-FFF2-40B4-BE49-F238E27FC236}">
                <a16:creationId xmlns:a16="http://schemas.microsoft.com/office/drawing/2014/main" id="{378943BA-8C13-5D0B-1967-3F6690876B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82D00-E18D-4D66-B3EE-0BEE78E5CE9D}" type="datetimeFigureOut">
              <a:rPr lang="nl-NL" smtClean="0"/>
              <a:t>21-07-2022</a:t>
            </a:fld>
            <a:endParaRPr lang="nl-NL"/>
          </a:p>
        </p:txBody>
      </p:sp>
      <p:sp>
        <p:nvSpPr>
          <p:cNvPr id="8" name="Tijdelijke aanduiding voor voettekst 7">
            <a:extLst>
              <a:ext uri="{FF2B5EF4-FFF2-40B4-BE49-F238E27FC236}">
                <a16:creationId xmlns:a16="http://schemas.microsoft.com/office/drawing/2014/main" id="{9279F558-3AAE-CB81-8C22-DEC9A8D29C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Tijdelijke aanduiding voor dianummer 8">
            <a:extLst>
              <a:ext uri="{FF2B5EF4-FFF2-40B4-BE49-F238E27FC236}">
                <a16:creationId xmlns:a16="http://schemas.microsoft.com/office/drawing/2014/main" id="{67FC259D-7978-3DAA-3B4B-6C6D7E1C11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059D-D019-4456-ABB0-D72F78B2AB1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2464911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08480CD-258C-5DF3-136B-0A967A82ED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datum 2">
            <a:extLst>
              <a:ext uri="{FF2B5EF4-FFF2-40B4-BE49-F238E27FC236}">
                <a16:creationId xmlns:a16="http://schemas.microsoft.com/office/drawing/2014/main" id="{5B06F848-A9E6-F62D-5EEB-24E38A87C1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82D00-E18D-4D66-B3EE-0BEE78E5CE9D}" type="datetimeFigureOut">
              <a:rPr lang="nl-NL" smtClean="0"/>
              <a:t>21-07-2022</a:t>
            </a:fld>
            <a:endParaRPr lang="nl-NL"/>
          </a:p>
        </p:txBody>
      </p:sp>
      <p:sp>
        <p:nvSpPr>
          <p:cNvPr id="4" name="Tijdelijke aanduiding voor voettekst 3">
            <a:extLst>
              <a:ext uri="{FF2B5EF4-FFF2-40B4-BE49-F238E27FC236}">
                <a16:creationId xmlns:a16="http://schemas.microsoft.com/office/drawing/2014/main" id="{33697122-A76B-2242-74CA-0265E10CEF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Tijdelijke aanduiding voor dianummer 4">
            <a:extLst>
              <a:ext uri="{FF2B5EF4-FFF2-40B4-BE49-F238E27FC236}">
                <a16:creationId xmlns:a16="http://schemas.microsoft.com/office/drawing/2014/main" id="{C6CBDBEB-571F-83C9-BF9A-482A5C926E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059D-D019-4456-ABB0-D72F78B2AB1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8025151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>
            <a:extLst>
              <a:ext uri="{FF2B5EF4-FFF2-40B4-BE49-F238E27FC236}">
                <a16:creationId xmlns:a16="http://schemas.microsoft.com/office/drawing/2014/main" id="{5D6A62B4-C87C-B966-C9A4-D7AF8909F0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82D00-E18D-4D66-B3EE-0BEE78E5CE9D}" type="datetimeFigureOut">
              <a:rPr lang="nl-NL" smtClean="0"/>
              <a:t>21-07-2022</a:t>
            </a:fld>
            <a:endParaRPr lang="nl-NL"/>
          </a:p>
        </p:txBody>
      </p:sp>
      <p:sp>
        <p:nvSpPr>
          <p:cNvPr id="3" name="Tijdelijke aanduiding voor voettekst 2">
            <a:extLst>
              <a:ext uri="{FF2B5EF4-FFF2-40B4-BE49-F238E27FC236}">
                <a16:creationId xmlns:a16="http://schemas.microsoft.com/office/drawing/2014/main" id="{037499F7-E384-D9CC-5EF1-A1AF68EAB5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dianummer 3">
            <a:extLst>
              <a:ext uri="{FF2B5EF4-FFF2-40B4-BE49-F238E27FC236}">
                <a16:creationId xmlns:a16="http://schemas.microsoft.com/office/drawing/2014/main" id="{03F65457-DE55-95A0-43F3-FFA2072775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059D-D019-4456-ABB0-D72F78B2AB1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4086446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ED34BB5-3610-0EAE-371A-5D370E9D6A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C85475B0-E26D-FC7D-4FE0-310D02E5D5E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:a16="http://schemas.microsoft.com/office/drawing/2014/main" id="{91B273FB-54E6-AD51-5E8E-CD6985593FC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357E04F9-E8BD-2F57-00BB-C615E39A3E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82D00-E18D-4D66-B3EE-0BEE78E5CE9D}" type="datetimeFigureOut">
              <a:rPr lang="nl-NL" smtClean="0"/>
              <a:t>21-07-2022</a:t>
            </a:fld>
            <a:endParaRPr lang="nl-NL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6EA3A6F2-F890-1986-AB63-90F3D852AB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168D7DD9-BE3E-D3D7-3762-B785960E5D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059D-D019-4456-ABB0-D72F78B2AB1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1362622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D954590-1425-C6E3-F10F-59E072DDAA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afbeelding 2">
            <a:extLst>
              <a:ext uri="{FF2B5EF4-FFF2-40B4-BE49-F238E27FC236}">
                <a16:creationId xmlns:a16="http://schemas.microsoft.com/office/drawing/2014/main" id="{DF281D52-0DCB-AAF5-0969-0A089DE0AD0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:a16="http://schemas.microsoft.com/office/drawing/2014/main" id="{92E324ED-52C7-0215-8826-C1DC9AAA63F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9434587D-1AFF-5DF7-EC4F-E5EBF17F62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82D00-E18D-4D66-B3EE-0BEE78E5CE9D}" type="datetimeFigureOut">
              <a:rPr lang="nl-NL" smtClean="0"/>
              <a:t>21-07-2022</a:t>
            </a:fld>
            <a:endParaRPr lang="nl-NL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6BA9020B-5DE2-2B65-5AC7-8298DE06B9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AADADE30-0903-537F-7287-4194DDAB60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059D-D019-4456-ABB0-D72F78B2AB1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0465416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>
            <a:extLst>
              <a:ext uri="{FF2B5EF4-FFF2-40B4-BE49-F238E27FC236}">
                <a16:creationId xmlns:a16="http://schemas.microsoft.com/office/drawing/2014/main" id="{25125828-40B5-CA13-F50B-32C8E05E70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54301654-BAAB-BC4E-9703-53034744A2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9B40498A-6335-F1A4-4555-178E13552FE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182D00-E18D-4D66-B3EE-0BEE78E5CE9D}" type="datetimeFigureOut">
              <a:rPr lang="nl-NL" smtClean="0"/>
              <a:t>21-07-2022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7EC8BC38-2552-624F-DB3E-A56E203D4A2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335EAA34-6273-3C9A-DF01-CCD1AF8DD85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6F059D-D019-4456-ABB0-D72F78B2AB1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5397530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https://doi.org/10.1111/tan.14626" TargetMode="Externa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kstvak 3">
            <a:extLst>
              <a:ext uri="{FF2B5EF4-FFF2-40B4-BE49-F238E27FC236}">
                <a16:creationId xmlns:a16="http://schemas.microsoft.com/office/drawing/2014/main" id="{AD3A2A8E-ECD7-44FC-A1C2-89537900E8A5}"/>
              </a:ext>
            </a:extLst>
          </p:cNvPr>
          <p:cNvSpPr txBox="1"/>
          <p:nvPr/>
        </p:nvSpPr>
        <p:spPr>
          <a:xfrm>
            <a:off x="574016" y="564961"/>
            <a:ext cx="11407815" cy="68464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fr-FR" sz="36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r>
              <a:rPr lang="nl-NL" sz="3600" b="1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LA-</a:t>
            </a:r>
            <a:r>
              <a:rPr lang="nl-NL" sz="3600" b="1" dirty="0" err="1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aulekule</a:t>
            </a:r>
            <a:r>
              <a:rPr lang="nl-NL" sz="3600" b="1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3600" b="1" dirty="0" err="1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è</a:t>
            </a:r>
            <a:r>
              <a:rPr lang="nl-NL" sz="3600" b="1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3600" b="1" dirty="0" err="1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ransplantasie</a:t>
            </a:r>
            <a:r>
              <a:rPr lang="nl-NL" sz="3600" b="1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nl-NL" sz="3600" b="1" dirty="0" err="1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âhtau-immunitèt</a:t>
            </a:r>
            <a:r>
              <a:rPr lang="nl-NL" sz="3600" b="1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en </a:t>
            </a:r>
            <a:r>
              <a:rPr lang="nl-NL" sz="3600" b="1" dirty="0" err="1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fektiebestrèding</a:t>
            </a:r>
            <a:r>
              <a:rPr lang="nl-NL" sz="3600" b="1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nl-NL" sz="3600" b="1" dirty="0" err="1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Un</a:t>
            </a:r>
            <a:r>
              <a:rPr lang="nl-NL" sz="3600" b="1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3600" b="1" dirty="0" err="1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tripboekavontuâh</a:t>
            </a:r>
            <a:r>
              <a:rPr lang="nl-NL" sz="3600" b="1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endParaRPr lang="nl-NL" sz="3600" kern="1400" spc="-50" dirty="0">
              <a:solidFill>
                <a:srgbClr val="FF0000"/>
              </a:solidFill>
              <a:effectLst/>
              <a:latin typeface="Calibri Light" panose="020F03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nl-NL" sz="2400" dirty="0">
                <a:solidFill>
                  <a:srgbClr val="FF0000"/>
                </a:solidFill>
              </a:rPr>
              <a:t>HLA </a:t>
            </a:r>
            <a:r>
              <a:rPr lang="nl-NL" sz="2400" dirty="0" err="1">
                <a:solidFill>
                  <a:srgbClr val="FF0000"/>
                </a:solidFill>
              </a:rPr>
              <a:t>molecules</a:t>
            </a:r>
            <a:r>
              <a:rPr lang="nl-NL" sz="2400" dirty="0">
                <a:solidFill>
                  <a:srgbClr val="FF0000"/>
                </a:solidFill>
              </a:rPr>
              <a:t> in </a:t>
            </a:r>
            <a:r>
              <a:rPr lang="nl-NL" sz="2400" dirty="0" err="1">
                <a:solidFill>
                  <a:srgbClr val="FF0000"/>
                </a:solidFill>
              </a:rPr>
              <a:t>transplantation</a:t>
            </a:r>
            <a:r>
              <a:rPr lang="nl-NL" sz="2400" dirty="0">
                <a:solidFill>
                  <a:srgbClr val="FF0000"/>
                </a:solidFill>
              </a:rPr>
              <a:t>, </a:t>
            </a:r>
            <a:r>
              <a:rPr lang="nl-NL" sz="2400" dirty="0" err="1">
                <a:solidFill>
                  <a:srgbClr val="FF0000"/>
                </a:solidFill>
              </a:rPr>
              <a:t>autoimmunity</a:t>
            </a:r>
            <a:r>
              <a:rPr lang="nl-NL" sz="2400" dirty="0">
                <a:solidFill>
                  <a:srgbClr val="FF0000"/>
                </a:solidFill>
              </a:rPr>
              <a:t> and </a:t>
            </a:r>
            <a:r>
              <a:rPr lang="nl-NL" sz="2400" dirty="0" err="1">
                <a:solidFill>
                  <a:srgbClr val="FF0000"/>
                </a:solidFill>
              </a:rPr>
              <a:t>infection</a:t>
            </a:r>
            <a:r>
              <a:rPr lang="nl-NL" sz="2400" dirty="0">
                <a:solidFill>
                  <a:srgbClr val="FF0000"/>
                </a:solidFill>
              </a:rPr>
              <a:t> control.</a:t>
            </a:r>
          </a:p>
          <a:p>
            <a:pPr algn="ctr"/>
            <a:r>
              <a:rPr lang="nl-NL" sz="2400" dirty="0">
                <a:solidFill>
                  <a:srgbClr val="FF0000"/>
                </a:solidFill>
              </a:rPr>
              <a:t>A comic </a:t>
            </a:r>
            <a:r>
              <a:rPr lang="nl-NL" sz="2400" dirty="0" err="1">
                <a:solidFill>
                  <a:srgbClr val="FF0000"/>
                </a:solidFill>
              </a:rPr>
              <a:t>Book</a:t>
            </a:r>
            <a:r>
              <a:rPr lang="nl-NL" sz="2400" dirty="0">
                <a:solidFill>
                  <a:srgbClr val="FF0000"/>
                </a:solidFill>
              </a:rPr>
              <a:t> adventure</a:t>
            </a:r>
          </a:p>
          <a:p>
            <a:pPr algn="ctr"/>
            <a:endParaRPr lang="nl-NL" sz="2400" dirty="0">
              <a:solidFill>
                <a:srgbClr val="FF0000"/>
              </a:solidFill>
            </a:endParaRPr>
          </a:p>
          <a:p>
            <a:pPr algn="ctr"/>
            <a:r>
              <a:rPr lang="nl-NL" sz="2400" dirty="0">
                <a:solidFill>
                  <a:srgbClr val="FF0000"/>
                </a:solidFill>
              </a:rPr>
              <a:t>by Eric Reits and Jacques Neefjes</a:t>
            </a:r>
          </a:p>
          <a:p>
            <a:pPr algn="ctr"/>
            <a:endParaRPr lang="nl-NL" sz="3200" dirty="0">
              <a:solidFill>
                <a:srgbClr val="FF0000"/>
              </a:solidFill>
            </a:endParaRPr>
          </a:p>
          <a:p>
            <a:pPr algn="ctr"/>
            <a:r>
              <a:rPr lang="fr-FR" sz="1800" i="1" dirty="0" err="1">
                <a:solidFill>
                  <a:srgbClr val="80808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ranslated</a:t>
            </a:r>
            <a:r>
              <a:rPr lang="fr-FR" sz="1800" i="1" dirty="0">
                <a:solidFill>
                  <a:srgbClr val="80808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by https://haags.nu/</a:t>
            </a:r>
            <a:r>
              <a:rPr lang="fr-FR" i="1" dirty="0">
                <a:solidFill>
                  <a:srgbClr val="808080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fr-FR" sz="1800" i="1" dirty="0">
                <a:solidFill>
                  <a:srgbClr val="80808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riginal </a:t>
            </a:r>
            <a:r>
              <a:rPr lang="fr-FR" sz="1800" i="1" dirty="0" err="1">
                <a:solidFill>
                  <a:srgbClr val="80808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ext</a:t>
            </a:r>
            <a:r>
              <a:rPr lang="fr-FR" sz="1800" i="1" dirty="0">
                <a:solidFill>
                  <a:srgbClr val="80808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: </a:t>
            </a:r>
            <a:r>
              <a:rPr lang="fr-FR" sz="1800" b="1" i="1" u="sng" dirty="0">
                <a:solidFill>
                  <a:srgbClr val="2F5496"/>
                </a:solidFill>
                <a:effectLst/>
                <a:latin typeface="Open Sans" panose="020B0606030504020204" pitchFamily="34" charset="0"/>
                <a:ea typeface="Calibri" panose="020F0502020204030204" pitchFamily="34" charset="0"/>
                <a:cs typeface="Arial" panose="020B0604020202020204" pitchFamily="34" charset="0"/>
                <a:hlinkClick r:id="rId2"/>
              </a:rPr>
              <a:t>https://doi.org/10.1111/tan.14626</a:t>
            </a:r>
            <a:endParaRPr lang="nl-NL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ctr"/>
            <a:endParaRPr lang="en-US" b="0" i="0" dirty="0">
              <a:solidFill>
                <a:srgbClr val="212121"/>
              </a:solidFill>
              <a:effectLst/>
              <a:latin typeface="BlinkMacSystemFont"/>
            </a:endParaRPr>
          </a:p>
          <a:p>
            <a:pPr algn="ctr"/>
            <a:r>
              <a:rPr lang="en-US" b="0" i="0" dirty="0">
                <a:solidFill>
                  <a:srgbClr val="212121"/>
                </a:solidFill>
                <a:effectLst/>
                <a:latin typeface="BlinkMacSystemFont"/>
              </a:rPr>
              <a:t>Department of Cell and Chemical Biology, ONCODE Institute, Leiden University Medical Centre LUMC, The Netherlands </a:t>
            </a:r>
          </a:p>
          <a:p>
            <a:pPr algn="ctr"/>
            <a:endParaRPr lang="nl-NL" sz="3200" dirty="0">
              <a:solidFill>
                <a:srgbClr val="FF0000"/>
              </a:solidFill>
            </a:endParaRPr>
          </a:p>
          <a:p>
            <a:pPr algn="ctr"/>
            <a:endParaRPr lang="nl-NL" sz="3200" dirty="0">
              <a:solidFill>
                <a:srgbClr val="FF0000"/>
              </a:solidFill>
            </a:endParaRPr>
          </a:p>
          <a:p>
            <a:pPr algn="ctr"/>
            <a:endParaRPr lang="nl-NL" sz="3200" dirty="0">
              <a:solidFill>
                <a:srgbClr val="FF0000"/>
              </a:solidFill>
            </a:endParaRPr>
          </a:p>
          <a:p>
            <a:pPr algn="ctr"/>
            <a:endParaRPr lang="nl-NL" sz="3200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082657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9233653-F5D1-4CE8-A085-E1D08840F7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l-NL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ia 9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8F3E082B-94F8-5931-DC6E-BD9AD1031BE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lvl="0" indent="0">
              <a:buNone/>
            </a:pP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arwi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ebaasd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hebbe gestaan. Hoe j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errefekt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agtn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u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rùi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 hoe j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u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eifseltransplantasi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ke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oâhkaum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en/of je de echt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ad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ke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in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dit zull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ni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elangrèkst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evolusionèâh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reidee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è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o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HLA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olymorrefisme</a:t>
            </a:r>
            <a:endParaRPr lang="nl-NL" sz="24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216843655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59F48DC-0862-6B44-FC9B-84AEC5FC5C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l-NL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ia 10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0F669CAB-FA0A-FF59-AA2E-BADF8CFAB33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lvl="0" indent="0">
              <a:buNone/>
            </a:pP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'r is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echt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nog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ander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faktor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iruss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en ander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athaugen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è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i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uvâhvloed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nwezag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in d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natu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Korauna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nflueza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Ebola,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okk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en veile ander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iruss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brùik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onz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el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om hu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èg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nageslac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t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kreërû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elluf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"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ellufbeperreken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"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nfeksie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âhw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audelij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è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ond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mmuunsysteim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De vraag is simpel: hoe ken u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mmuunsysteim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iruss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eitekter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ie i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el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op d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loe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legg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 om ze t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au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oâhdat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ze ons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kenn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odû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?</a:t>
            </a: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159915008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B9D1AA8-26FC-C43A-B81F-74780B8220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l-NL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ia 11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D7EF5935-B29B-4E2C-7ADF-AEEC9533C3A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lvl="0" indent="0">
              <a:buNone/>
            </a:pP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m schad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o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iruss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t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eperrek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ep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u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mmuunsysteim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eâhder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ape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ontwikkeld.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klèn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opsomming: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akrofag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eit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aktâhrië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e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iruss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; neutrofiel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iv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audelijk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toff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af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aktâhrië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; B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el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mak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ntilicham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; T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elp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el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helpe B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el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en ander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el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; T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kill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el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(CTL)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au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met virus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ïnfekteâh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el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(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elluf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kankercel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).</a:t>
            </a: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370730615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62E386C-A960-3855-36DC-866A912968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l-NL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ia 12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040D62E5-283F-32D2-0110-F1AE207BC62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lvl="0" indent="0">
              <a:buNone/>
            </a:pP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aa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hoe wei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T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kill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cel wat hè mo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odû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? Ut virus, dat z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èg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in de cel bevind, is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fgescherremp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eig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eiteksi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en dus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nzichbaa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of klop di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ni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? Inderdaad,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erwèl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ut virus z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èg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emenigvuldigt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og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klèn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stukkies va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è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èwitt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fgelevegd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HLA-A-, -B- of -C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auleku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ie z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naa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u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eloppâhvla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ranspogtâhû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De T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kill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-cel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eâhkent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i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klèn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fragmen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am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met u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peicifie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HLA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aulekuul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De ontdekking van di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fenaumei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da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iruss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eâhkend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og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via d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èwitt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i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u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ransplantasi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fstauting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kenn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eroâhzak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was voldoend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elangrè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om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wei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Naubelleprèzû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!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Elle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nd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type MHC klasse I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aulekuul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reisenteâht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andere set van peptide va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virus om u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mmuunsysteim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efficiënt virus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ïnfekteâh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 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el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t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odû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</a:t>
            </a: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285677000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F04D3A8-8F06-4C35-65F2-125CFE270F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l-NL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ia 13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D615539A-E8F3-6217-F3AB-AC25ABDCC1A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lvl="0" indent="0">
              <a:buNone/>
            </a:pP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aa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ho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ogt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fragment va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virus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èwit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ègelij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maa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? Viral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èwitt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og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- net as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elle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nd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èwit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i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el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– na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èdsj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fgebrokû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Èwitt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og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fragmenteâhd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o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pmerrekelijk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nanomasjin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u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augenaam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rauteijasaum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 da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fètelij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afvalbak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o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èwitt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is.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ndâhr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ezym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in de cel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knipp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ùitèn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van d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fragment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i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klèner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fragment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(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u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wel peptid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noemp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),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aahva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sommig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annut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ytausaul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naa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e ER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og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transpogteâhd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aa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ze HLA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auleku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kenn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indû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audra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HLA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aulekuul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bon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peptid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ep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elaat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ut de ER e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erreplaat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z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èg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naa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u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eloppâhvla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aa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u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ac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op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eiteksi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o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T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killercelle</a:t>
            </a:r>
            <a:endParaRPr lang="nl-NL" sz="24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337421969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6F02E08-E3D2-17E5-DC75-DD6B4ECE8A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l-NL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ia14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21C45FCE-B3D9-B62B-4DA3-740D3F03FF8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92500"/>
          </a:bodyPr>
          <a:lstStyle/>
          <a:p>
            <a:pPr marL="0" lvl="0" indent="0">
              <a:buNone/>
            </a:pP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Late w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erugker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naa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HLA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olymorrefism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aua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ederei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weit wat KAUVID-19 en griep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è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è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iruss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errag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goed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nnut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erander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e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kenn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aahdo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 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ntsnapp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ntilicham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eig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u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eâhder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virus (denk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llufa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delta,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umikro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….). Om t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oâhkaum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a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virus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nnut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fweâhsysteim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ke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ntsnapp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reisenteâht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elle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van d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eschillen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MHC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llei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(i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ep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'r 3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ajj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ad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e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ajj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oedâhr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kreigû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!)  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andere se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eptidû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D'r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og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auveil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eschillen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peptide i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ei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egsau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preisenteâhd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da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iruss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moeilijk all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ekwensie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kenn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npassû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D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eschil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in HLA-types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uss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ens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eteiken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a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elluf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as di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beuâht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u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ntwèken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virus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è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bedrog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è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e vollegend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egsau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ni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zal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olhâhwû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As we allemaal HLA-identiek war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wei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ntsnapped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virus d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ei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evolleking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au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n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zal ut '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lech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'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aa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ndividu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au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met HLA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auleku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i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ni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in staa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è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virale peptid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nnut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mmuunsysteim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t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reisentâhû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ndâhr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ens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met andere HLA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auleku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on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wau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e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andere peptid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annut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elluf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virus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nnut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fweâhsysteim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HLA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olymorrefism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escherremp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us d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aupelasi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ut individu is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ind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elangrè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Dit bied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uvâhtùige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eklaring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o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evolusi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van MHC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olymorrefism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</a:t>
            </a: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398048329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5F034E7-8C58-B232-73DD-59EF65D581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l-NL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ia 15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62A13C40-AE6F-8C15-A7A9-5C2718A6906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lvl="0" indent="0">
              <a:buNone/>
            </a:pP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aah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helaas, beste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leizâh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is dit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lech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nieuws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oâh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u indien u nieuwe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âhgane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naudag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ep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HLA-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olymorrefisme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evogdeg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ut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ogtbestaan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van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ogt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aupelasie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aah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nie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van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individu met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nieâhziekte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ransplantasie-afstauting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ollegt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indien ut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mmuunsysteim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onorauâhgaan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ewagt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met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oâh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virus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ïnfekteâhd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âhgaan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(de HLA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aulekule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met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virus peptide zien d'r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etzellufde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ùit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oâh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he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fweâh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ysteim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as andere HLA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lleile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) en dan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reijageâht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oâh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ut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âhgaan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n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te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alle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wat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resulteâht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in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fstauting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annut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transplantaat</a:t>
            </a: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4246810808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F18CEC3-8A55-BF0C-9518-4DFC95E1E7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l-NL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ia 16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4D8975BA-7FFC-30AA-15D3-41FA27B8877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elangrèk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lgemein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les: niets,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u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u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mmuunsysteim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ni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is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errefe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!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èvoâhbeild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late we 'ns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nadenk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uv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hoe T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killercel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snel genoeg virus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ïnfekteâh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el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kenn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in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om va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enag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nut t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è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iruss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kenn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hu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nakaumeling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e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snel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rauducer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in sommige gevalle i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lech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enkel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rû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Dit is te langzaam om t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acht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tot viral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èwitt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nnut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èn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van hu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natuâhlijk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leiv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og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fgebrauk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(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uâht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al snel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of 10).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aa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net as u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mmuunsysteim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elluf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is d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yntheis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va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èwitt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dus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u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viral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èwitt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verre va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errefe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eiz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mperrefekt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èwitt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RiP'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naamp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og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onmiddellijk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fgebrauk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aahdo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ut begin va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irusinfeksi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ogt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gekoppeld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reisentasi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va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fragmen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annut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virus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o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MHC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auleku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an en da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effektiev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eliminasi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van d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el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ie net virus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è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a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mak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o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T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kill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elle</a:t>
            </a:r>
            <a:endParaRPr lang="nl-NL" sz="24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3899695511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FF62DF6-95F5-0A91-249E-F9AA639101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dirty="0">
                <a:solidFill>
                  <a:schemeClr val="accent1">
                    <a:lumMod val="75000"/>
                  </a:schemeClr>
                </a:solidFill>
                <a:latin typeface="+mn-lt"/>
                <a:ea typeface="Arial" panose="020B0604020202020204" pitchFamily="34" charset="0"/>
              </a:rPr>
              <a:t>Dia</a:t>
            </a:r>
            <a:r>
              <a:rPr lang="nl-NL" sz="4400" dirty="0">
                <a:solidFill>
                  <a:schemeClr val="accent1">
                    <a:lumMod val="75000"/>
                  </a:schemeClr>
                </a:solidFill>
                <a:effectLst/>
                <a:latin typeface="+mn-lt"/>
                <a:ea typeface="Arial" panose="020B0604020202020204" pitchFamily="34" charset="0"/>
              </a:rPr>
              <a:t> 17</a:t>
            </a:r>
            <a:endParaRPr lang="nl-NL" dirty="0">
              <a:latin typeface="+mn-lt"/>
            </a:endParaRP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4AF0C3D3-497F-57DF-EB53-9C655C0C53B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lvl="0" indent="0">
              <a:buNone/>
            </a:pP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us u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mmuunsysteim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wint? Ni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au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snel! Sommige slimm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iruss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oâhal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errepesviruss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è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ëvolueâhd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om hu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èg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reisentasi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o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MHC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auleku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t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erstorû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U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fweâhsysteim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is dan blind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o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eiz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irussû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Humaa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ytaumeigelauviru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HCMV, dat 60% van d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enshèd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nfekteâht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maak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reik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èwitt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(US2, US3, US6, US11 en US18) die d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eptideprauduksi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eperrek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of de HLA klasse I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funksi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erstorû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</a:t>
            </a: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1105366937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2D822B6-A984-57BD-90EA-A9F8FB9125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z="4400" dirty="0">
                <a:solidFill>
                  <a:schemeClr val="accent1">
                    <a:lumMod val="75000"/>
                  </a:schemeClr>
                </a:solidFill>
                <a:effectLst/>
                <a:latin typeface="+mn-lt"/>
                <a:ea typeface="Arial" panose="020B0604020202020204" pitchFamily="34" charset="0"/>
              </a:rPr>
              <a:t>Dia</a:t>
            </a:r>
            <a:r>
              <a:rPr lang="nl-NL" sz="4400" dirty="0">
                <a:solidFill>
                  <a:schemeClr val="accent1">
                    <a:lumMod val="75000"/>
                  </a:schemeClr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18</a:t>
            </a:r>
            <a:endParaRPr lang="nl-NL" dirty="0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330442D2-B232-FD7F-958C-A57EDA7A894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lvl="0" indent="0">
              <a:buNone/>
            </a:pP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s ut da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augelij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at sommige HLA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llei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et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è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in d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kontrau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va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irusinfeksie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an andere? Inderdaad, sommige HLA-B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llei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escherrem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et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eig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HIV,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erwèl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 ander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et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è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eig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Kauvid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D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eschillen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HLA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llei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è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in d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laup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van d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eeuw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iselekteâhd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om me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eschillen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athaugen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om t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a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HLA-A2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ogt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èvoâhbeild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ngetroff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è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40% van d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Euraipeis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evolleking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Dit is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aahschènlij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u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volleg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va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virus die de mes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errege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nnut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eleij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ko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au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ezè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eiz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ens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HLA-A2 maakte om  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eig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it virus t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escherrem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it virus ken allang al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edwen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è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aa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HLA-A2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ni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</a:t>
            </a: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7975525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BD3A73D-003C-6F05-0119-DC1064BCD1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br>
              <a:rPr lang="nl-NL" sz="4900" b="1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nl-NL" sz="4900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ia 1</a:t>
            </a:r>
            <a:b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br>
              <a:rPr lang="nl-NL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</a:br>
            <a:endParaRPr lang="nl-NL" dirty="0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AA1E52C6-CD66-ECAF-6D93-C00CE5D5DE6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au'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1900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jaa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leij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oeâh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wei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rabies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roeâh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e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linici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 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Kosma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en Damianus,  d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eâhst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eintransplantasi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ùit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è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eving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u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angreineuz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ei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va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kaupma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 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o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at va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è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slaaf. Ut lot van de slaaf is in de geschiedenis onbekend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bleiv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aa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at di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rèwillag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ging,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lè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 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nwaahschènlij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</a:t>
            </a:r>
          </a:p>
          <a:p>
            <a:pPr marL="0" indent="0">
              <a:buNone/>
            </a:pPr>
            <a:endParaRPr lang="nl-NL" sz="2400" dirty="0">
              <a:effectLst/>
              <a:latin typeface="Arial" panose="020B0604020202020204" pitchFamily="34" charset="0"/>
              <a:ea typeface="Arial" panose="020B0604020202020204" pitchFamily="34" charset="0"/>
            </a:endParaRP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3257974897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65B4228-2A30-085C-36FF-163A608EBE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dirty="0">
                <a:solidFill>
                  <a:schemeClr val="accent1">
                    <a:lumMod val="75000"/>
                  </a:schemeClr>
                </a:solidFill>
                <a:latin typeface="+mn-lt"/>
                <a:ea typeface="Arial" panose="020B0604020202020204" pitchFamily="34" charset="0"/>
              </a:rPr>
              <a:t>Dia</a:t>
            </a:r>
            <a:r>
              <a:rPr lang="nl-NL" sz="4400" dirty="0">
                <a:solidFill>
                  <a:schemeClr val="accent1">
                    <a:lumMod val="75000"/>
                  </a:schemeClr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19</a:t>
            </a:r>
            <a:endParaRPr lang="nl-NL" dirty="0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8DC9713E-B1AA-AAA1-80DB-8BC72F2CB18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lvl="0" indent="0">
              <a:buNone/>
            </a:pP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aah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'r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èn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neiveneffektûh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Neim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ut HLA-allel HLA-B*27:05. Dit is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nwezag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in 8% van de blanke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aupelasie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en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eâh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an 90% van de patiënte met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nkylausing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pondilitis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(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ein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ogt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reuma)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ep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it allel, wat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aahschènlijk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âhtau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-immuun T-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elreijaksie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in de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ervellekaulom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eroâhzaak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Ut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mmuunsysteim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errek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op ut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nèvlak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usse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ut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iede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van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effektieve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mmunitèt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eige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nfeksies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 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erwèl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ut de gezonde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eifsels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met rus mot late om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au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âhtoimmuunziekte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auas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reuma en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ùikerziekte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te </a:t>
            </a:r>
            <a:r>
              <a:rPr lang="nl-NL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oâhkaume</a:t>
            </a:r>
            <a: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</a:t>
            </a: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2232336142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13D90D2-18BB-A630-C9AE-2099718E30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z="4400" dirty="0">
                <a:solidFill>
                  <a:schemeClr val="accent1">
                    <a:lumMod val="75000"/>
                  </a:schemeClr>
                </a:solidFill>
                <a:effectLst/>
                <a:latin typeface="+mn-lt"/>
                <a:ea typeface="Arial" panose="020B0604020202020204" pitchFamily="34" charset="0"/>
                <a:cs typeface="SimSun" panose="02010600030101010101" pitchFamily="2" charset="-122"/>
              </a:rPr>
              <a:t>Dia </a:t>
            </a:r>
            <a:r>
              <a:rPr lang="nl-NL" sz="4400" dirty="0">
                <a:solidFill>
                  <a:schemeClr val="accent1">
                    <a:lumMod val="75000"/>
                  </a:schemeClr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20</a:t>
            </a:r>
            <a:endParaRPr lang="nl-NL" dirty="0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DE971C2A-0729-047A-A820-01BC12AB11D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lvl="0" indent="0">
              <a:buNone/>
            </a:pP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eâhkenning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va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èg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èwitt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o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u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fweâhsysteim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ke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u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unstag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è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Kankercel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kenn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ypie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veil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utasie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en ander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erandering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i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lè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tot u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inerer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van peptide va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muteâh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èwitt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i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eschil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va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noâhma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eptidû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mmunotheâhapi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eig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kank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maak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brùi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van mechanisme di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o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u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mmuunsysteim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og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brùi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è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u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eâhkenn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van virale e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aktâhrië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nfeksie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om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kankercel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t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odû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En u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erre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!</a:t>
            </a:r>
          </a:p>
          <a:p>
            <a:pPr marL="0" indent="0">
              <a:buNone/>
            </a:pPr>
            <a:endParaRPr lang="nl-NL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977480240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0B693BD-48E0-4EF7-ED76-990E17D397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z="4400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Arial" panose="020B0604020202020204" pitchFamily="34" charset="0"/>
                <a:cs typeface="Calibri" panose="020F0502020204030204" pitchFamily="34" charset="0"/>
              </a:rPr>
              <a:t>Dia</a:t>
            </a:r>
            <a:r>
              <a:rPr lang="nl-NL" sz="4400" dirty="0">
                <a:solidFill>
                  <a:schemeClr val="accent1">
                    <a:lumMod val="75000"/>
                  </a:schemeClr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21</a:t>
            </a:r>
            <a:endParaRPr lang="nl-NL" dirty="0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5FB1583F-B431-0AB0-AF00-0271AA9970B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lvl="0" indent="0">
              <a:buNone/>
            </a:pP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aa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hoe zit ut met de HLA-DR, -DQ en -DP MHC klasse II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aulekulû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?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eiz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auleku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reisenter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athaugen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peptid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T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elpâhcel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di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evollege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ytaukin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rauducer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om B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el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te helpe z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èg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om t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âhw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tot antilichaam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rauduceren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fabriekû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T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elpâhcel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help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u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om T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killerreijaksie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t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ptimaliserû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</a:t>
            </a:r>
          </a:p>
          <a:p>
            <a:pPr marL="0" indent="0">
              <a:buNone/>
            </a:pP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HC klasse II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lè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quwa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orrem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terre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op MHC klasse I,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aa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bind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èwitfragment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i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lang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è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e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maa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i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lysausomû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Di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è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klèn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laassie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i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èwitt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fbreik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 die va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ùitû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el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è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ekreigû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</a:t>
            </a: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451666271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9FE66FB-45B4-26E7-29DC-3C3177AEB9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z="4400" dirty="0">
                <a:solidFill>
                  <a:schemeClr val="accent1">
                    <a:lumMod val="75000"/>
                  </a:schemeClr>
                </a:solidFill>
                <a:effectLst/>
                <a:latin typeface="+mn-lt"/>
                <a:ea typeface="Arial" panose="020B0604020202020204" pitchFamily="34" charset="0"/>
                <a:cs typeface="SimSun" panose="02010600030101010101" pitchFamily="2" charset="-122"/>
              </a:rPr>
              <a:t>Dia</a:t>
            </a:r>
            <a:r>
              <a:rPr lang="nl-NL" sz="4400" dirty="0">
                <a:solidFill>
                  <a:schemeClr val="accent1">
                    <a:lumMod val="75000"/>
                  </a:schemeClr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22</a:t>
            </a:r>
            <a:endParaRPr lang="nl-NL" dirty="0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8772CEAC-C439-B0A6-1373-EAC7FC76178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lvl="0" indent="0">
              <a:buNone/>
            </a:pP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oe doen ze dit? MHC klasse II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ogt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maa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nnut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ER (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aua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elle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nd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èwit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a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naa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u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ùitemembraa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of d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lysausom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van de cel mot)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aa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u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èwit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(invariant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keit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) bind da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peptid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nabaut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en MHC klasse II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naa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u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lysausaum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egelèd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ie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ogt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e invariant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keit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ewèdâhd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e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ùitgewisseld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o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peptide da's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maa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o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lysausoma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rauteijase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Di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rauce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ogt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optimaliseâhd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o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nog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nd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type MHC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aulekuul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(HLA-DM), da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lè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op MHC klasse II en in sommig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el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amewerre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met HLA-DO,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e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nd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klasse II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chtag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aulekuul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Evolusi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is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lùi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anne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u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erreken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aulekuul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ep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ontwikkeld, zal u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eiz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einvâhdag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kaupiër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e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èzig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o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nieuw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funksie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Ut nettoresultaat va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eiz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kompliceâh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ans is d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fleivering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van MHC klasse II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auleku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nnut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eloppâhvla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met peptide die T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elp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el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a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ktiveû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</a:t>
            </a: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221640483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22E148C-0204-A5B2-584D-70B575CAC8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z="4400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Arial" panose="020B0604020202020204" pitchFamily="34" charset="0"/>
                <a:cs typeface="Calibri" panose="020F0502020204030204" pitchFamily="34" charset="0"/>
              </a:rPr>
              <a:t>Dia</a:t>
            </a:r>
            <a:r>
              <a:rPr lang="nl-NL" sz="4400" dirty="0">
                <a:solidFill>
                  <a:schemeClr val="accent1">
                    <a:lumMod val="75000"/>
                  </a:schemeClr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23</a:t>
            </a:r>
            <a:endParaRPr lang="nl-NL" dirty="0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52E73233-8116-47A7-F8C4-09BB63E96A0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lvl="0" indent="0">
              <a:buNone/>
            </a:pP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i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rauce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va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eâhkenning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va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iektevewekkâh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o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u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mmuunsysteim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is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komplex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..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aa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u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relatief traag. D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eâhst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ke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at u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virus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eigenkomp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ep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u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mmuunsysteim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èd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naudag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om de antivirale respons op t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oerû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ssu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pech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ep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ken di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lè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tot ziekte of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uvâhlè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o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ngekontrauleâh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virus groei.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aksinasi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erèd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u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mmuunsysteim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o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op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nfeksi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aahdo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ut in sommige gevall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nfeksi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olledag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ke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oâhkaum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e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ndâh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nell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e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effektiev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ke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reijager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om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audoen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e kans op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errenstig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nfeksi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nzienlij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t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eklènû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</a:t>
            </a: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2051388773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F0486EC-8194-8DE9-E4A4-E2AAF1C92A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z="4400" dirty="0">
                <a:solidFill>
                  <a:schemeClr val="accent1">
                    <a:lumMod val="75000"/>
                  </a:schemeClr>
                </a:solidFill>
                <a:effectLst/>
                <a:latin typeface="+mn-lt"/>
                <a:ea typeface="Arial" panose="020B0604020202020204" pitchFamily="34" charset="0"/>
                <a:cs typeface="SimSun" panose="02010600030101010101" pitchFamily="2" charset="-122"/>
              </a:rPr>
              <a:t>Dia </a:t>
            </a:r>
            <a:r>
              <a:rPr lang="nl-NL" sz="4400" dirty="0">
                <a:solidFill>
                  <a:schemeClr val="accent1">
                    <a:lumMod val="75000"/>
                  </a:schemeClr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24</a:t>
            </a:r>
            <a:endParaRPr lang="nl-NL" dirty="0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B6AB1605-8F7E-4B97-A278-F43BF950DC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lvl="0" indent="0">
              <a:buNone/>
            </a:pP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HC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auleku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è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krucia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eilnemâh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aksinasi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All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aksin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mak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brùi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van MHC klasse II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auleku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om T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elpâhcel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t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nducer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i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naudag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è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o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ntilichaamreijaksie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en om d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èwitt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te mak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aa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eig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ntilichaamreijaksie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è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ric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denauviru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- en mRNA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aksin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brùik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u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MHC klasse I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auleku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om T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killercel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t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nducerû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T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el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i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o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aksin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og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ïnduceâhd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a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veil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jar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mei,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omp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elluf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iental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jar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op hun hoed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o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nieuw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nfeksi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met u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âhspronkelijk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virus.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aksin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hebbe veil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e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leve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gered dan alle ander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edies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ntâhvensie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amû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egsprèd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eiz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audschap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ni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e ziekte, laat j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aksinerû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!</a:t>
            </a: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424675893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9E1BA61-07AA-CEF8-0C2B-349998946C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l-NL" b="1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pilaug</a:t>
            </a:r>
            <a:endParaRPr lang="nl-NL" dirty="0">
              <a:solidFill>
                <a:schemeClr val="accent1">
                  <a:lumMod val="75000"/>
                </a:schemeClr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EF9017E9-E812-639F-5573-4CE0C6045D6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us MHC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auleku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kontrauler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nfeksie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reguler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mmuunreijaksie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en help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n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kank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t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nezû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Dit is u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nadeil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va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âhtau-immunitèt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e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ransplantaatafstauting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eik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aahd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E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arom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ep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u – as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leivend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ez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nnu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wereld vol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iektevewekkâh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- u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uvâhleif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om dit stripboek t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leizû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Zi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referensie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1-6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o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e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nfoâhmasi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uv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hoe u nog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et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ke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uvâhleivû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</a:t>
            </a: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12542889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8F4E690-BB7D-56E3-9B4D-44AED3FCE8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l-NL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ia 2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BC4E3E5C-3222-4D47-F65D-B9C0E113156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eiz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"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ondâhbaahlijk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"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ransplantasi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roeg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è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hu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aligveklaring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e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è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er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aahdo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to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atraunhèlag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van d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ransplantasi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enoemp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è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nam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o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lief da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è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er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nthauf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anweig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hun christelijk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lauf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etgei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aahschènlij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emellepogt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og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korrigeâhd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 </a:t>
            </a:r>
          </a:p>
          <a:p>
            <a:endParaRPr lang="nl-NL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174125261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0AF41DB-8AD7-62FB-35A3-644127A279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l-NL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ia 3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C09D1FD8-FD8C-0FC2-1BDE-DE21F307175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lvl="0" indent="0">
              <a:buNone/>
            </a:pP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arom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is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ransplantasi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au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moeilijk? Wa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è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evolusionèâh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reidee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?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elluf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arwin mot ut z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èg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hebb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fgevraag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.. Hè wis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mmâh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niets af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uv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unieke klasse va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èwitt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i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o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èna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all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eâhcellag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eukaryaut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maa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ogdû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</a:t>
            </a: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97149517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5D465DA-A226-751A-9D77-AC1C39048B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l-NL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ia 4 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91A68588-9BB9-E15F-EF94-FCFDF25FB3C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lvl="0" indent="0">
              <a:buNone/>
            </a:pP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m dat t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egrèp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late we beginne met u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ùideg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begrip va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wei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unieke klasse va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èwitt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in ons lichaam.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eiz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èwitt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hebbe d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augst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graad va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olymorrefism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(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eschil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uss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ons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ens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).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eiz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è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uniek omda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èna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alle ander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èwitt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nagenoeg identiek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è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è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ensû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eiz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olymorref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èwitt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è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e "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ransplantasi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-antigein" e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og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nnut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lgemei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MHC-klasse I en MHC-klasse II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auleku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noemp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è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ens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og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ze HLA-klasse I en HLA-klasse II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noemp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</a:t>
            </a: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196424112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CBB3EF4-1D46-3BF9-67F9-3E19D136FA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l-NL" dirty="0">
                <a:solidFill>
                  <a:schemeClr val="accent1">
                    <a:lumMod val="75000"/>
                  </a:schemeClr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ia</a:t>
            </a:r>
            <a:r>
              <a:rPr lang="nl-NL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5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2F399C68-360A-0E99-8103-AD9D3593631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lvl="0" indent="0">
              <a:buNone/>
            </a:pP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elangrèkst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HLA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auleku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o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ransplantasi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og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HLA-A, HLA-B en HLA-C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o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MHC klasse I en HLA-DR, HLA-DQ en HLA-DP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o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MHC klasse II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noemp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HLA-A, -B en -C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è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nwezag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i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rèwel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al onz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el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(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ehallev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rau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loedcel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),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erwèl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HLA-DR, HLA-DQ en HLA-DP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oâhnamelij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op immuu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el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ittû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</a:t>
            </a: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171479073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023177E-39EF-C28E-0D5D-FBEB282A55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l-NL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ia 6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6B1D9D5B-196E-F09F-908C-B4F021443B8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lvl="0" indent="0">
              <a:buNone/>
            </a:pP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LA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auleku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è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au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eschillend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(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olymorref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) dat zwanger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râhw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vaak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ntistoff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nmak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eig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eschillen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HLA-types van d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ad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ie de foetus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e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ërf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ep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ieâhmei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kon d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ad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bepaald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og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in d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èd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att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nog gei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neties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tests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eschikbaa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arû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eiz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sera van zwanger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râhw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er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echt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u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brùi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è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eifseltransplantasi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Laboratoria wisselde  sera va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eiz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zwanger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râhw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ùit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en d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eschillen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erumreijaksie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er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in HLA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urreksjop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esprokû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au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er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HLA-A, -B en -C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ïdentificeâhd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e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u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eschillen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orrem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ieâhva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eiz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er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simpelweg HLA-A1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nummegd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de vollegende HLA-A2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ez.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i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beuâh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u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met de HLA-DR-, -DQ- en -DP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aulekulû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Uw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eifsel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kenn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us (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èvoâhbeild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) HLA-A1, -B8, -Cw7, -DR3, -DQ2 en DPw1-èwitte van uw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oedâhr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en HLA-A2, -B27, -Cw1, -DR4, -DQ3, en DPw4-èwitte van uw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ad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evattû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</a:t>
            </a: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383241885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09E8373-2BA6-76FF-3BCA-0444305D79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l-NL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ia 7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BAD2A4F0-809A-C03C-FBF9-FC47D504D08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lvl="0" indent="0">
              <a:buNone/>
            </a:pP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eigewoâhdag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ogt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HLA-typering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roetinematag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ùitgevoeâhd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middels DNA-analyses. D'r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è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nwèzing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a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râhw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eschil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in HLA-types va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ann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kenn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ndâhschè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e hand va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u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etgei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èdraagt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natuâhlijk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eleksi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va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netie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eschillen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agtnâhs</a:t>
            </a:r>
            <a:endParaRPr lang="nl-NL" sz="24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352641294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003AC5E-8008-CAB6-B198-9912DDEB50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l-NL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ia 8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482C5A00-9AE1-8FE9-A1E3-6B2D57C48CE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lvl="0" indent="0">
              <a:buNone/>
            </a:pP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oewel HLA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olymorrefism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ken helpe om d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enshèd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t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eschillend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te make,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errep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u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enoâhm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arrèjerr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op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o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uksesvoll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âhgaantransplantasie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omdat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aahbè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e HLA-type van d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ntvang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en de donor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zau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goed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augelij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op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elkaa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mott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og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fgestemp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stâh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gei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errefekt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match is,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ogd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effektiev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immunosuppressiva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ebrùi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om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âhgaanafstauting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t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voâhkaume</a:t>
            </a:r>
            <a:endParaRPr lang="nl-NL" sz="24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4159430860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3</TotalTime>
  <Words>2329</Words>
  <Application>Microsoft Office PowerPoint</Application>
  <PresentationFormat>Widescreen</PresentationFormat>
  <Paragraphs>63</Paragraphs>
  <Slides>2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6</vt:i4>
      </vt:variant>
    </vt:vector>
  </HeadingPairs>
  <TitlesOfParts>
    <vt:vector size="32" baseType="lpstr">
      <vt:lpstr>Arial</vt:lpstr>
      <vt:lpstr>BlinkMacSystemFont</vt:lpstr>
      <vt:lpstr>Calibri</vt:lpstr>
      <vt:lpstr>Calibri Light</vt:lpstr>
      <vt:lpstr>Open Sans</vt:lpstr>
      <vt:lpstr>Kantoorthema</vt:lpstr>
      <vt:lpstr>PowerPoint Presentation</vt:lpstr>
      <vt:lpstr> Dia 1  </vt:lpstr>
      <vt:lpstr>Dia 2</vt:lpstr>
      <vt:lpstr>Dia 3</vt:lpstr>
      <vt:lpstr>Dia 4 </vt:lpstr>
      <vt:lpstr>Dia 5</vt:lpstr>
      <vt:lpstr>Dia 6</vt:lpstr>
      <vt:lpstr>Dia 7</vt:lpstr>
      <vt:lpstr>Dia 8</vt:lpstr>
      <vt:lpstr>Dia 9</vt:lpstr>
      <vt:lpstr>Dia 10</vt:lpstr>
      <vt:lpstr>Dia 11</vt:lpstr>
      <vt:lpstr>Dia 12</vt:lpstr>
      <vt:lpstr>Dia 13</vt:lpstr>
      <vt:lpstr>Dia14</vt:lpstr>
      <vt:lpstr>Dia 15</vt:lpstr>
      <vt:lpstr>Dia 16</vt:lpstr>
      <vt:lpstr>Dia 17</vt:lpstr>
      <vt:lpstr>Dia18</vt:lpstr>
      <vt:lpstr>Dia19</vt:lpstr>
      <vt:lpstr>Dia 20</vt:lpstr>
      <vt:lpstr>Dia 21</vt:lpstr>
      <vt:lpstr>Dia 22</vt:lpstr>
      <vt:lpstr>Dia 23</vt:lpstr>
      <vt:lpstr>Dia 24</vt:lpstr>
      <vt:lpstr>Epilaug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Neefjes, J.J.C. (CCB)</dc:creator>
  <cp:lastModifiedBy>Boer-Theirlynck, J.J.A. de (CCB)</cp:lastModifiedBy>
  <cp:revision>13</cp:revision>
  <dcterms:created xsi:type="dcterms:W3CDTF">2022-06-25T11:50:20Z</dcterms:created>
  <dcterms:modified xsi:type="dcterms:W3CDTF">2022-07-21T08:54:36Z</dcterms:modified>
</cp:coreProperties>
</file>